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sldIdLst>
    <p:sldId id="256" r:id="rId2"/>
  </p:sldIdLst>
  <p:sldSz cx="7315200" cy="117046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6"/>
    <p:restoredTop sz="94663"/>
  </p:normalViewPr>
  <p:slideViewPr>
    <p:cSldViewPr snapToGrid="0" snapToObjects="1">
      <p:cViewPr varScale="1">
        <p:scale>
          <a:sx n="68" d="100"/>
          <a:sy n="68" d="100"/>
        </p:scale>
        <p:origin x="3184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915552"/>
            <a:ext cx="6217920" cy="4074948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6147645"/>
            <a:ext cx="5486400" cy="282591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147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892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623163"/>
            <a:ext cx="1577340" cy="991914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623163"/>
            <a:ext cx="4640580" cy="991914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51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044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918035"/>
            <a:ext cx="6309360" cy="4868803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7832899"/>
            <a:ext cx="6309360" cy="2560389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260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3115818"/>
            <a:ext cx="3108960" cy="7426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3115818"/>
            <a:ext cx="3108960" cy="7426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536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3166"/>
            <a:ext cx="6309360" cy="22623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869263"/>
            <a:ext cx="3094672" cy="1406181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4275444"/>
            <a:ext cx="3094672" cy="628853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869263"/>
            <a:ext cx="3109913" cy="1406181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4275444"/>
            <a:ext cx="3109913" cy="628853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097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884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117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780309"/>
            <a:ext cx="2359342" cy="2731082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685254"/>
            <a:ext cx="3703320" cy="8317879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511391"/>
            <a:ext cx="2359342" cy="650528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662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780309"/>
            <a:ext cx="2359342" cy="2731082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685254"/>
            <a:ext cx="3703320" cy="8317879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511391"/>
            <a:ext cx="2359342" cy="650528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675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623166"/>
            <a:ext cx="6309360" cy="22623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3115818"/>
            <a:ext cx="6309360" cy="7426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10848468"/>
            <a:ext cx="1645920" cy="623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60C5CA-F177-244A-A334-16695E8441EF}" type="datetimeFigureOut">
              <a:rPr lang="en-US" smtClean="0"/>
              <a:t>6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10848468"/>
            <a:ext cx="2468880" cy="623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10848468"/>
            <a:ext cx="1645920" cy="623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17056-71D0-BB47-9503-204297C5D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19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CF5F0579-9167-2D43-B018-B71FD6A5EC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4583"/>
            <a:ext cx="7315200" cy="9405257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9C89DF76-B3FC-DA4B-9F96-41BB775B49B0}"/>
              </a:ext>
            </a:extLst>
          </p:cNvPr>
          <p:cNvSpPr/>
          <p:nvPr/>
        </p:nvSpPr>
        <p:spPr>
          <a:xfrm>
            <a:off x="0" y="9422533"/>
            <a:ext cx="73152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Supplementary</a:t>
            </a:r>
            <a:r>
              <a:rPr lang="zh-CN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Figure </a:t>
            </a: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3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Abnormal intestinal villus morphology in the HIV-infected individuals abusing opioids. (A)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Small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Intestinal sections harvested from the healthy controls, the patients abusing opioids, the HIV-infected patients and HIV-infected opioid abusers were stained with hematoxylin &amp; eosin (H&amp;E) (left panel, scale bar: 50μm). Immunofluorescence was performed for claudin-1 (middle panel) and Ki67 (right panel, scale bar: 25μm; white arrow: Ki67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+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cells) (B) Intestinal tissue damages were scored based on a histological scoring system. Each dot represents one patient (n=2 or 3). ANOVA followed by Bonferroni correction, F (3, 7) = 15.67,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ANOVA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=0.0017.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P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values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for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group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compariso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are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show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i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the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figure.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(C) Claudin-1 (green) expression levels were quantified by measuring the intensity of green fluorescence within each villus. Quantification from 3 different fields for each patient is depicted (n=6 or 9). ANOVA followed by Bonferroni correction, F (3, 29) = 37.59,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ANOVA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P&lt;0.0001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P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values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for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group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compariso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are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show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i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the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figure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(D) The percentage of Ki67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(green) cells in each crypt was quantified. Quantification from 9 different crypts for each patient is depicted (n=18 or 27). ANOVA followed by Bonferroni correction, F (3, 95) = 71.14, ANOVA P&lt;0.0001.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P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values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for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group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compariso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are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show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in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the</a:t>
            </a:r>
            <a:r>
              <a:rPr lang="zh-CN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Cambria" panose="02040503050406030204" pitchFamily="18" charset="0"/>
              </a:rPr>
              <a:t>figure.</a:t>
            </a:r>
            <a:endParaRPr lang="en-US" sz="1200" dirty="0">
              <a:latin typeface="Cambria" panose="02040503050406030204" pitchFamily="18" charset="0"/>
              <a:ea typeface="SimSun" panose="02010600030101010101" pitchFamily="2" charset="-122"/>
              <a:cs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2486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279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g, Jingjing</dc:creator>
  <cp:lastModifiedBy>Meng, Jingjing</cp:lastModifiedBy>
  <cp:revision>5</cp:revision>
  <dcterms:created xsi:type="dcterms:W3CDTF">2019-06-23T16:02:44Z</dcterms:created>
  <dcterms:modified xsi:type="dcterms:W3CDTF">2019-06-24T14:25:42Z</dcterms:modified>
</cp:coreProperties>
</file>